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9" r:id="rId4"/>
    <p:sldId id="268" r:id="rId5"/>
    <p:sldId id="267" r:id="rId6"/>
    <p:sldId id="264" r:id="rId7"/>
    <p:sldId id="263" r:id="rId8"/>
    <p:sldId id="262" r:id="rId9"/>
    <p:sldId id="266" r:id="rId10"/>
    <p:sldId id="257" r:id="rId11"/>
    <p:sldId id="258" r:id="rId12"/>
  </p:sldIdLst>
  <p:sldSz cx="9144000" cy="6858000" type="screen4x3"/>
  <p:notesSz cx="6797675" cy="987266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B301B821-A1FF-4177-AEE7-76D212191A09}" styleName="보통 스타일 1 - 강조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밝은 스타일 1 - 강조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D27102A9-8310-4765-A935-A1911B00CA55}" styleName="밝은 스타일 1 - 강조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17292A2E-F333-43FB-9621-5CBBE7FDCDCB}" styleName="밝은 스타일 2 - 강조 4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</a:tcStyle>
    </a:band1H>
    <a:band1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1V>
    <a:band2V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4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10" d="100"/>
          <a:sy n="110" d="100"/>
        </p:scale>
        <p:origin x="-1560" y="-11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1669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6988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5799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8398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7056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8167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329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31697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5694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82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1527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960870-0D94-4432-B095-044497F85027}" type="datetimeFigureOut">
              <a:rPr lang="ko-KR" altLang="en-US" smtClean="0"/>
              <a:pPr/>
              <a:t>2015-03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F5FDD4-4B39-462D-A2D4-691B5F270F1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83302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150227"/>
            <a:ext cx="8604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Table A.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Minimal common regions of recurrent (&gt;20%) copy number gains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1257362"/>
              </p:ext>
            </p:extLst>
          </p:nvPr>
        </p:nvGraphicFramePr>
        <p:xfrm>
          <a:off x="179512" y="602937"/>
          <a:ext cx="8784976" cy="5832984"/>
        </p:xfrm>
        <a:graphic>
          <a:graphicData uri="http://schemas.openxmlformats.org/drawingml/2006/table">
            <a:tbl>
              <a:tblPr>
                <a:tableStyleId>{B301B821-A1FF-4177-AEE7-76D212191A09}</a:tableStyleId>
              </a:tblPr>
              <a:tblGrid>
                <a:gridCol w="658873"/>
                <a:gridCol w="617060"/>
                <a:gridCol w="802016"/>
                <a:gridCol w="656195"/>
                <a:gridCol w="583284"/>
                <a:gridCol w="729105"/>
                <a:gridCol w="4738443"/>
              </a:tblGrid>
              <a:tr h="2616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omoso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o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ban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1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r>
                        <a:rPr lang="en-US" altLang="ko-KR" sz="800" b="1" u="none" strike="noStrike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r>
                        <a:rPr lang="en-US" altLang="ko-KR" sz="800" baseline="300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altLang="ko-KR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0988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1385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7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36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6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KI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87440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878094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91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42.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USP5P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3525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3723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5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IAA1106,MYT1L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83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366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2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5.3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CDC127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933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070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5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XOC2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10385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10498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CML4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773201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773506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4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5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6orf35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054453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054808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5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5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LC22A1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1255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205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00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2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BXL18</a:t>
                      </a:r>
                    </a:p>
                  </a:txBody>
                  <a:tcPr marL="2901" marR="2901" marT="2901" marB="0" anchor="ctr"/>
                </a:tc>
              </a:tr>
              <a:tr h="14487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205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9285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230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2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TB,ACTG1,BC044606,DL492006,FBXL18,FSCN1,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NF216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90537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91857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2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Q601342,PMS2L13,SPDYE3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98878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99814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6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2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4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PDYE2,SPDYE6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15270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15402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1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6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TPRN2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1145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5295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50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23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K307331,FLJ00326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40041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75939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897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RIB1,BX648371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40140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62831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690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2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Q515898,DQ515899,LOC727677,POU5F1B,POU5F1P1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62831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39309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478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2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042052,MYC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077031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48080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04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8 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X748239,TRAPPC9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49546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63400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85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HRAC1,DQ574852,EIF2C2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6340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95587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18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KFZp666O0110,EIF2C2,PTK2</a:t>
                      </a:r>
                    </a:p>
                  </a:txBody>
                  <a:tcPr marL="2901" marR="2901" marT="2901" marB="0" anchor="ctr"/>
                </a:tc>
              </a:tr>
              <a:tr h="14771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7772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88424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0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K124079,DKFZp434I2135,FAM83H,LOC100130274,MAPK15,SCRIB,ZNF707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88425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95544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19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PPK1,NRBP2,PUF60,SCRIB,pp9320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9554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01082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37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LEC1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01082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0742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45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INA,PARP10,PLEC1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07428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11082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5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-OPase,OPLAH,SPATC1</a:t>
                      </a:r>
                    </a:p>
                  </a:txBody>
                  <a:tcPr marL="2901" marR="2901" marT="2901" marB="0" anchor="ctr"/>
                </a:tc>
              </a:tr>
              <a:tr h="242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11082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1816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81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-OPase,CYC1,DKFZp434F0427,EXOSC4,GPAA1,KIAA1875,MAF1,OPLAH,SHARPIN,hSIPL1A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18164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23678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14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8orf30A,HEATR7A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23678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27500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21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EATR7A</a:t>
                      </a:r>
                    </a:p>
                  </a:txBody>
                  <a:tcPr marL="2901" marR="2901" marT="2901" marB="0" anchor="ctr"/>
                </a:tc>
              </a:tr>
              <a:tr h="14771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27500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58172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672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OP1,C8orf30A,C8orfK29,DGAT,DGAT1,FBXL6,HEATR7A,HSF1,SCRT1,SCXB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58172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59697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BXL6,GPR172A</a:t>
                      </a:r>
                    </a:p>
                  </a:txBody>
                  <a:tcPr marL="2901" marR="2901" marT="2901" marB="0" anchor="ctr"/>
                </a:tc>
              </a:tr>
              <a:tr h="242975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5969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75047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49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DCK5,AK094577,AK298596,CPSF1,CR612338,CYHR1,FOXH1,GPT,KIFC2,LRRC14,LRRC24,MFSD3,NFKBIL2,PPP1R16A,RECQL4,SLC39A4,VPS28</a:t>
                      </a:r>
                    </a:p>
                  </a:txBody>
                  <a:tcPr marL="2901" marR="2901" marT="2901" marB="0" anchor="ctr"/>
                </a:tc>
              </a:tr>
              <a:tr h="147719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75047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75498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1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8orf82,CR612338,KIAA1688,LRRC14,LRRC24,MGC70857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75498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80224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26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4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KIAA1688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43319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643430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2.3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8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HF2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168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330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5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IP2C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331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511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5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DARB2,NCRNA00168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00033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00217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RTP1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60194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60349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4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LJ44054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77306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85268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62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ASA3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256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532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5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3.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4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MFN1876,LA16c-360B4.1,LMF1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92689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92929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0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1.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040860</a:t>
                      </a:r>
                    </a:p>
                  </a:txBody>
                  <a:tcPr marL="2901" marR="2901" marT="2901" marB="0" anchor="ctr"/>
                </a:tc>
              </a:tr>
              <a:tr h="122916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766030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79246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43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13.1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045185</a:t>
                      </a:r>
                    </a:p>
                  </a:txBody>
                  <a:tcPr marL="2901" marR="2901" marT="2901" marB="0" anchor="ctr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9216496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79512" y="476672"/>
            <a:ext cx="8100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Table H.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MLPA probe sequences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8" name="표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85770103"/>
              </p:ext>
            </p:extLst>
          </p:nvPr>
        </p:nvGraphicFramePr>
        <p:xfrm>
          <a:off x="251520" y="1052736"/>
          <a:ext cx="8640960" cy="4229800"/>
        </p:xfrm>
        <a:graphic>
          <a:graphicData uri="http://schemas.openxmlformats.org/drawingml/2006/table">
            <a:tbl>
              <a:tblPr/>
              <a:tblGrid>
                <a:gridCol w="936104"/>
                <a:gridCol w="3744416"/>
                <a:gridCol w="3960440"/>
              </a:tblGrid>
              <a:tr h="31826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 Name 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eft Probe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quence (5’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맑은 고딕"/>
                          <a:cs typeface="Times New Roman" pitchFamily="18" charset="0"/>
                        </a:rPr>
                        <a:t>→ 3’)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b="1" i="0" u="none" strike="noStrike" dirty="0" smtClean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marL="0" marR="0" indent="0" algn="l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ight </a:t>
                      </a: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be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quence </a:t>
                      </a: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5’ </a:t>
                      </a: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→ 3’)</a:t>
                      </a:r>
                      <a:endParaRPr lang="en-US" altLang="ko-KR" sz="1000" b="1" i="0" u="none" strike="noStrike" dirty="0" smtClean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  <a:p>
                      <a:pPr algn="l" fontAlgn="ctr"/>
                      <a:endParaRPr lang="en-US" sz="10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27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Y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TTCCCTAAGGGTTGGAGTTGGAGCGCCAGAGGAGGAACGAGCTAA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GGAGCTTTTTTGCCCTGCGTGACCAGATCTCTAGATTGGATCTTGCTGGCA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27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HI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TTCCCTAAGGGTTGGACCATGTAATACAACAGAACTGTCCTTCGCTCTTGTG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ATAGGAAACCTGTGGTACCAGGACGTATCCTTTCTTTATCATGAGATTTAGGTGACATCTAGATTGGATCTTGCTGGCA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27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L4A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TTCCCTAAGGGTTGGAGAGGCTCACCTGGGATGGATGG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CAAGGCATGCCTGGACTCAAAGGGATCTAGATTGGATCTTGCTGGC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27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WDR6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TTCCCTAAGGGTTGGACCATGTAATACGACTGCACAGAGAGAAGAAGCTGCGTAAGGAGTATGAGA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ACCTTCCTGAACATAAGGAGCCGAGGTTTCATGAGATTTAGGTTCTAGATTGGATCTTGCTGGC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279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FATC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TTCCCTAAGGGTTGGACCATGTAATACGACTGACTAGGCTGCGAGAGGACTCTAGTATGAGTCTCCAACATTT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AACGTTTCCTGGGCTGTCACGTACACTCCTTTCATGAGATTTAGGTGACTCTAGATTGGATCTTGCTGGCAC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2792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COA3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TTCCCTAAGGGTTGGACCATGTAAGATCAAAATACTTGCTGGATGGTGGAC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GAGACCAATAAAAATAAACTGCTTGAACATCCTTTGATTCATGAGTCTAGATTGGATCTTGCTGGCA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20652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467544" y="836712"/>
            <a:ext cx="842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Times New Roman" pitchFamily="18" charset="0"/>
                <a:cs typeface="Times New Roman" pitchFamily="18" charset="0"/>
              </a:rPr>
              <a:t>           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Table I. </a:t>
            </a:r>
            <a:r>
              <a:rPr lang="en-US" altLang="ko-KR" b="1" dirty="0" err="1" smtClean="0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 primer sequences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9" name="표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4411990"/>
              </p:ext>
            </p:extLst>
          </p:nvPr>
        </p:nvGraphicFramePr>
        <p:xfrm>
          <a:off x="1115616" y="1412776"/>
          <a:ext cx="7056338" cy="3780420"/>
        </p:xfrm>
        <a:graphic>
          <a:graphicData uri="http://schemas.openxmlformats.org/drawingml/2006/table">
            <a:tbl>
              <a:tblPr/>
              <a:tblGrid>
                <a:gridCol w="1079674"/>
                <a:gridCol w="2952328"/>
                <a:gridCol w="3024336"/>
              </a:tblGrid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 Name 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eft Primer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quence </a:t>
                      </a: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5’ </a:t>
                      </a: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→ 3’)</a:t>
                      </a:r>
                      <a:endParaRPr lang="en-US" altLang="ko-KR" sz="1000" b="1" i="0" u="none" strike="noStrike" dirty="0" smtClean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ctr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ight Primer </a:t>
                      </a:r>
                      <a:r>
                        <a:rPr lang="en-US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quence </a:t>
                      </a: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(5’ </a:t>
                      </a:r>
                      <a:r>
                        <a:rPr lang="en-US" altLang="ko-KR" sz="10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ea typeface="+mn-ea"/>
                          <a:cs typeface="Times New Roman" pitchFamily="18" charset="0"/>
                        </a:rPr>
                        <a:t>→ 3’)</a:t>
                      </a:r>
                      <a:endParaRPr lang="en-US" altLang="ko-KR" sz="1000" b="1" i="0" u="none" strike="noStrike" dirty="0" smtClean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PLPO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CTTGTCTGTGGAGACGGATTA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CCAAGAAGGCCTTGACCT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HI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TGGGACCTCTCTCACCTTT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GGACGTGAACGTGCTTC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CRIB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TGCCCAAGCCTTTTTTC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ACCGCTGGATCTCGTTGT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Y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GCTGCTTAGACGCTGGAT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CGAGTCGTAGTCGAGGTCA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2F1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TGACTCTGCCACCATAGTGTC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ACAACAGCGGTTCTTGC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COA3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CGGCGAGTTTCCGATTT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GAGTCCACCATCCAGCAAG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NTA1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GCGAGGCCAAACACATGT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CGAGCAGATCTCCAGATACC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40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CCAAGAAGCCAACCAAT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GGAAGATCGTCGGGAAA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YA2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TGTGGGACTTGGATGAGACA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CGTGGTGTCCTTCCCGTAT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UF60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GGCTACGGCTTCATTGAGTAC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ACCCAGGTCAAAGAGGTTC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OP1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TGATGCCCAACTGCAAGTG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TGCTATCGTAGCTCCCACAGA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RK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TCCCCAAAAGGGTCGTAGTAG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CTGCTGGATCCCATTAGTTAGG</a:t>
                      </a: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003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MAD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CGAAGGCAGACGGTAACA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CTTGAGCAACGCACTGA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80" marR="5080" marT="508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745234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14094" y="150227"/>
            <a:ext cx="8604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Table A.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Minimal common regions of recurrent (&gt;20%) copy number gains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11733087"/>
              </p:ext>
            </p:extLst>
          </p:nvPr>
        </p:nvGraphicFramePr>
        <p:xfrm>
          <a:off x="251520" y="548680"/>
          <a:ext cx="8640960" cy="5820948"/>
        </p:xfrm>
        <a:graphic>
          <a:graphicData uri="http://schemas.openxmlformats.org/drawingml/2006/table">
            <a:tbl>
              <a:tblPr>
                <a:tableStyleId>{B301B821-A1FF-4177-AEE7-76D212191A09}</a:tableStyleId>
              </a:tblPr>
              <a:tblGrid>
                <a:gridCol w="653518"/>
                <a:gridCol w="612044"/>
                <a:gridCol w="795498"/>
                <a:gridCol w="650862"/>
                <a:gridCol w="732059"/>
                <a:gridCol w="569663"/>
                <a:gridCol w="4627316"/>
              </a:tblGrid>
              <a:tr h="26573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omoso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op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ban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r>
                        <a:rPr lang="en-US" sz="800" b="1" u="none" strike="noStrike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r>
                        <a:rPr lang="en-US" altLang="ko-KR" sz="800" baseline="300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2901" marR="2901" marT="2901" marB="0" anchor="ctr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05267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22037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769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EFB124,HM13,ID1,NCRNA00028,PSIMCT-1,REM1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22037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23685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48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X4I2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236855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39940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255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L2L1,TPX2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39940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53105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164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USP15,FOXS1,MLCK2,MYLK2,TTLL9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53105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54297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915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DRG1,TTLL9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54297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62026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7295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20orf160,XKR7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62027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74986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959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CK,TM9SF4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74986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86207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1221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LAGL2,POFUT1,TM9SF4,TSPYL3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086207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00800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45926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XH1,ASXL1,KIAA0359,KIF3B</a:t>
                      </a:r>
                    </a:p>
                  </a:txBody>
                  <a:tcPr marL="4974" marR="4974" marT="4974" marB="0"/>
                </a:tc>
              </a:tr>
              <a:tr h="14712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00800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09535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735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XH1,ASXL1,C20orf112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09535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16160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624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20orf112,LOC284804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16197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42985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6787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OMMD7,DNMT3B,LOC149950,LOC284805,MAPRE1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42985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59471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4866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FCAB8,MAPRE1,SPAG4L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59471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68085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613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PIL1,BPIL3,C20orf185,C20orf186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68085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84904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818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ASE,C20orf186,C20orf70,C20orf71,PLUNC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84904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91946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704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20orf114,UNQ706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919465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04497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5505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K5RAP1,SNTA1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04497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08871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373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BFA2T2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08871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25335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4646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1-q11.2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20orf144,CBFA2T2,DKFZp313F2116,NECAB3,XB51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25335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39328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3992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20orf134,E2F1,NECAB3,PXMP4,XB51,ZNF341</a:t>
                      </a:r>
                    </a:p>
                  </a:txBody>
                  <a:tcPr marL="4974" marR="4974" marT="4974" marB="0"/>
                </a:tc>
              </a:tr>
              <a:tr h="1500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39328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242816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488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1.2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5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HMP4B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40735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42265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530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7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NTTIP1,WFDC3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42265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61561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9296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7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 smtClean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OT8,AK054694,C20orf161,C20orf165,CTSA,DNTTIP1,NEURL2,PCIF1,PLTP,SNX21,TNNC2,UBE2C,ZNF335,ZSWIM1,ZSWIM3,hNAACT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6156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78586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024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40,KIAA1176,KIAA1637,MMP9,NCOA5,SLC12A5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78586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95985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7398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H22</a:t>
                      </a:r>
                    </a:p>
                  </a:txBody>
                  <a:tcPr marL="4974" marR="4974" marT="4974" marB="0"/>
                </a:tc>
              </a:tr>
              <a:tr h="14107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95985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0105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065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LMO2,OVCOV1,SLC35C2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7447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82785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313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EYA2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582785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604866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0815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K098067,BC047609,KIAA1125,ZMYND8,hCG_2018772</a:t>
                      </a:r>
                    </a:p>
                  </a:txBody>
                  <a:tcPr marL="4974" marR="4974" marT="4974" marB="0"/>
                </a:tc>
              </a:tr>
              <a:tr h="1500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604866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626483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1616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1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036778,NCOA3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54223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584417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2185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037891,BMP7</a:t>
                      </a:r>
                    </a:p>
                  </a:txBody>
                  <a:tcPr marL="4974" marR="4974" marT="4974" marB="0"/>
                </a:tc>
              </a:tr>
              <a:tr h="11738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584417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596465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048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0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037891,RAE1,SPO11</a:t>
                      </a:r>
                    </a:p>
                  </a:txBody>
                  <a:tcPr marL="4974" marR="4974" marT="4974" marB="0"/>
                </a:tc>
              </a:tr>
              <a:tr h="1500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5965195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605036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517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0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BM38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605101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609525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424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0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ORIS,CTCFL,HMGB1L1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609525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640702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1177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0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R612603,CTCFL,PCK1,PMEPA1,ZBP1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5957833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026414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85806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7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DH4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36157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374366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279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30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IME1,SLC2A4RG,Si-1-2-19,ZGPAT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37436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39097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661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LC2A4RG,Si-1-2-19,ZBTB46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39097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397148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17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ZBTB46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397149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482896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8574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BC002534,ZBTB46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482897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52394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4104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20orf135,OK/SW-cl.69,TPD52L2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523942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546366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242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DNAJC5</a:t>
                      </a:r>
                    </a:p>
                  </a:txBody>
                  <a:tcPr marL="4974" marR="4974" marT="4974" marB="0"/>
                </a:tc>
              </a:tr>
              <a:tr h="12413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0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804921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62807594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67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q13.33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0.28 </a:t>
                      </a:r>
                    </a:p>
                  </a:txBody>
                  <a:tcPr marL="4974" marR="4974" marT="4974" marB="0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YT1</a:t>
                      </a:r>
                    </a:p>
                  </a:txBody>
                  <a:tcPr marL="4974" marR="4974" marT="4974" marB="0"/>
                </a:tc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>
            <a:off x="202990" y="6424761"/>
            <a:ext cx="703330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>
              <a:defRPr/>
            </a:pPr>
            <a:r>
              <a:rPr lang="en-US" altLang="ko-KR" sz="1000" dirty="0" smtClean="0"/>
              <a:t> </a:t>
            </a:r>
            <a:r>
              <a:rPr lang="en-US" altLang="ko-KR" sz="10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000" dirty="0" err="1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When</a:t>
            </a:r>
            <a:r>
              <a:rPr lang="en-US" altLang="ko-KR" sz="10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CNAs occurred within whole DNA sequence of a gene, the gene is depicted as bold.</a:t>
            </a:r>
          </a:p>
        </p:txBody>
      </p:sp>
    </p:spTree>
    <p:extLst>
      <p:ext uri="{BB962C8B-B14F-4D97-AF65-F5344CB8AC3E}">
        <p14:creationId xmlns:p14="http://schemas.microsoft.com/office/powerpoint/2010/main" val="9636186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표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3865299"/>
              </p:ext>
            </p:extLst>
          </p:nvPr>
        </p:nvGraphicFramePr>
        <p:xfrm>
          <a:off x="395536" y="1268760"/>
          <a:ext cx="7992887" cy="2771030"/>
        </p:xfrm>
        <a:graphic>
          <a:graphicData uri="http://schemas.openxmlformats.org/drawingml/2006/table">
            <a:tbl>
              <a:tblPr>
                <a:tableStyleId>{1FECB4D8-DB02-4DC6-A0A2-4F2EBAE1DC90}</a:tableStyleId>
              </a:tblPr>
              <a:tblGrid>
                <a:gridCol w="704175"/>
                <a:gridCol w="591969"/>
                <a:gridCol w="576064"/>
                <a:gridCol w="648072"/>
                <a:gridCol w="504056"/>
                <a:gridCol w="648072"/>
                <a:gridCol w="4320479"/>
              </a:tblGrid>
              <a:tr h="364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omoso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op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band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r>
                        <a:rPr lang="en-US" sz="800" b="1" u="none" strike="noStrike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mbol</a:t>
                      </a:r>
                      <a:r>
                        <a:rPr lang="en-US" sz="800" b="1" u="none" strike="noStrike" baseline="300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426341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48124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899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4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HI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37989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60500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510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2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M190A,KIAA168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35114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717384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624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5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034307,BC038717,FAT1,MTNR1A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71738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88355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617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5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FP4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88355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9372116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8855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35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7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Y494056,FLJ25801,TRIML1,TRIML2,ZFP4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63630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83698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68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K2,park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082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13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0551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3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XN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81374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2639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126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3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R</a:t>
                      </a:r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NXN,</a:t>
                      </a:r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M22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72640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803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392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3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SC5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8033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044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2415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3.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RK,YWHA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373673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452348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675</a:t>
                      </a:r>
                      <a:endParaRPr lang="en-US" altLang="ko-KR" sz="8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1.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0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MAD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  <a:tr h="20054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593666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791718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052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2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800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 </a:t>
                      </a:r>
                      <a:endParaRPr lang="en-US" altLang="ko-KR" sz="8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LL3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5093" marR="5093" marT="5093" marB="0" anchor="ctr"/>
                </a:tc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1764" y="764704"/>
            <a:ext cx="88204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Times New Roman" pitchFamily="18" charset="0"/>
                <a:cs typeface="Times New Roman" pitchFamily="18" charset="0"/>
              </a:rPr>
              <a:t>   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Table B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. Minimal common regions of recurrent (&gt;20%) copy number losses 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395536" y="4080783"/>
            <a:ext cx="7033305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ctr">
              <a:defRPr/>
            </a:pPr>
            <a:r>
              <a:rPr lang="en-US" altLang="ko-KR" sz="1100" b="1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100" dirty="0" err="1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When</a:t>
            </a:r>
            <a:r>
              <a:rPr lang="en-US" altLang="ko-KR" sz="11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CNAs occurred within whole DNA sequence of a gene, the gene is depicted as bold</a:t>
            </a:r>
            <a:r>
              <a:rPr lang="en-US" altLang="ko-KR" sz="10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551803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11560" y="78982"/>
            <a:ext cx="813690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 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C.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y number alterations according to Lauren’s classification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2080623"/>
              </p:ext>
            </p:extLst>
          </p:nvPr>
        </p:nvGraphicFramePr>
        <p:xfrm>
          <a:off x="1043608" y="456679"/>
          <a:ext cx="6768751" cy="6337084"/>
        </p:xfrm>
        <a:graphic>
          <a:graphicData uri="http://schemas.openxmlformats.org/drawingml/2006/table">
            <a:tbl>
              <a:tblPr firstRow="1" bandRow="1">
                <a:tableStyleId>{17292A2E-F333-43FB-9621-5CBBE7FDCDCB}</a:tableStyleId>
              </a:tblPr>
              <a:tblGrid>
                <a:gridCol w="1046082"/>
                <a:gridCol w="1690222"/>
                <a:gridCol w="1152127"/>
                <a:gridCol w="1512168"/>
                <a:gridCol w="1368152"/>
              </a:tblGrid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y number gain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use-type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testinal-type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alue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RIB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UF6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PK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OP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2F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TA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CL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OA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YA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02044">
                <a:tc>
                  <a:txBody>
                    <a:bodyPr/>
                    <a:lstStyle/>
                    <a:p>
                      <a:pPr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265392">
                <a:tc>
                  <a:txBody>
                    <a:bodyPr/>
                    <a:lstStyle/>
                    <a:p>
                      <a:pPr latinLnBrk="1"/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194004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1142142"/>
            <a:ext cx="84249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Times New Roman" pitchFamily="18" charset="0"/>
                <a:cs typeface="Times New Roman" pitchFamily="18" charset="0"/>
              </a:rPr>
              <a:t>       </a:t>
            </a:r>
            <a:r>
              <a:rPr lang="en-US" altLang="ko-KR" b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Table D. </a:t>
            </a:r>
            <a:r>
              <a:rPr lang="en-US" altLang="ko-KR" b="1" dirty="0" smtClean="0">
                <a:latin typeface="Times New Roman" pitchFamily="18" charset="0"/>
                <a:cs typeface="Times New Roman" pitchFamily="18" charset="0"/>
              </a:rPr>
              <a:t>Prevalence of copy number gains at 8q24 and 20q11.21 (or 20q13.12)</a:t>
            </a:r>
            <a:endParaRPr lang="ko-KR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6874212"/>
              </p:ext>
            </p:extLst>
          </p:nvPr>
        </p:nvGraphicFramePr>
        <p:xfrm>
          <a:off x="1043608" y="1844824"/>
          <a:ext cx="7056785" cy="195728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16224"/>
                <a:gridCol w="806490"/>
                <a:gridCol w="1411357"/>
                <a:gridCol w="1670585"/>
                <a:gridCol w="1152129"/>
              </a:tblGrid>
              <a:tr h="185420">
                <a:tc rowSpan="2" gridSpan="2">
                  <a:txBody>
                    <a:bodyPr/>
                    <a:lstStyle/>
                    <a:p>
                      <a:pPr algn="ctr" latinLnBrk="1"/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pPr algn="ctr" latinLnBrk="1"/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y number gains at</a:t>
                      </a:r>
                      <a:r>
                        <a:rPr lang="en-US" altLang="ko-KR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0q11.21 or 20q13.12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/>
                      <a:endParaRPr lang="en-US" altLang="ko-KR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value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440040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438584">
                <a:tc rowSpan="2"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py number gains at 8q24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latinLnBrk="1"/>
                      <a:endParaRPr lang="en-US" altLang="ko-KR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</a:t>
                      </a:r>
                      <a:r>
                        <a:rPr lang="en-US" altLang="ko-KR" sz="1800" b="1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ko-KR" alt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438584"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s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  <a:endParaRPr lang="ko-KR" altLang="en-US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>
            <a:off x="1006104" y="3783414"/>
            <a:ext cx="83529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d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Fisher’s exact test</a:t>
            </a:r>
          </a:p>
        </p:txBody>
      </p:sp>
    </p:spTree>
    <p:extLst>
      <p:ext uri="{BB962C8B-B14F-4D97-AF65-F5344CB8AC3E}">
        <p14:creationId xmlns:p14="http://schemas.microsoft.com/office/powerpoint/2010/main" val="359471552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4100949"/>
              </p:ext>
            </p:extLst>
          </p:nvPr>
        </p:nvGraphicFramePr>
        <p:xfrm>
          <a:off x="395536" y="1124744"/>
          <a:ext cx="8280920" cy="4810760"/>
        </p:xfrm>
        <a:graphic>
          <a:graphicData uri="http://schemas.openxmlformats.org/drawingml/2006/table">
            <a:tbl>
              <a:tblPr firstRow="1" bandRow="1">
                <a:tableStyleId>{5FD0F851-EC5A-4D38-B0AD-8093EC10F338}</a:tableStyleId>
              </a:tblPr>
              <a:tblGrid>
                <a:gridCol w="639474"/>
                <a:gridCol w="1304742"/>
                <a:gridCol w="1368152"/>
                <a:gridCol w="1080120"/>
                <a:gridCol w="1512168"/>
                <a:gridCol w="1224136"/>
                <a:gridCol w="1152128"/>
              </a:tblGrid>
              <a:tr h="370840">
                <a:tc>
                  <a:txBody>
                    <a:bodyPr/>
                    <a:lstStyle/>
                    <a:p>
                      <a:pPr algn="ctr" latinLnBrk="1"/>
                      <a:endParaRPr lang="en-US" altLang="ko-KR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.</a:t>
                      </a:r>
                      <a:endParaRPr lang="ko-KR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</a:t>
                      </a:r>
                      <a:endParaRPr lang="ko-KR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nd</a:t>
                      </a:r>
                      <a:endParaRPr lang="ko-KR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</a:t>
                      </a:r>
                      <a:endParaRPr lang="ko-KR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H-244K</a:t>
                      </a:r>
                      <a:r>
                        <a:rPr lang="en-US" altLang="ko-KR" sz="14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&amp; aCGH-400K (N=40)</a:t>
                      </a:r>
                      <a:r>
                        <a:rPr lang="en-US" altLang="ko-KR" sz="14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ko-KR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14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GH-60K (N=48)</a:t>
                      </a:r>
                      <a:r>
                        <a:rPr lang="en-US" altLang="ko-KR" sz="1400" baseline="300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ko-KR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endParaRPr lang="en-US" altLang="ko-KR" sz="1400" i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1400" i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altLang="ko-KR" sz="14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r>
                        <a:rPr lang="en-US" altLang="ko-KR" sz="14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r>
                        <a:rPr lang="en-US" altLang="ko-KR" sz="1400" baseline="300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ko-KR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1663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1777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923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374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90398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90536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7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685385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685498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2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70770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871061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0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06578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606731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47163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47472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9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133201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13510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0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60682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608856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10576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10723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234387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23593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34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</a:t>
                      </a:r>
                      <a:endParaRPr lang="ko-KR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376218" y="404664"/>
            <a:ext cx="86409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E.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copy number losses between aCGH-244K/-400K and </a:t>
            </a:r>
          </a:p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GH-60K</a:t>
            </a:r>
            <a:endParaRPr lang="ko-KR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76218" y="5962660"/>
            <a:ext cx="856895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s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columns of aCGH-244K </a:t>
            </a:r>
            <a:r>
              <a:rPr lang="en-US" altLang="ko-KR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amp; aCGH-400 and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GH-60K</a:t>
            </a:r>
            <a:r>
              <a:rPr lang="ko-KR" alt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dicate samples with copy number losses.</a:t>
            </a:r>
          </a:p>
          <a:p>
            <a:r>
              <a:rPr lang="en-US" altLang="ko-KR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1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values are based on Pearson’s chi-square or Fisher’s exact test.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9998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611560" y="332656"/>
            <a:ext cx="79208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F.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al common </a:t>
            </a:r>
            <a:r>
              <a:rPr lang="en-US" altLang="ko-K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gions</a:t>
            </a:r>
            <a:r>
              <a:rPr lang="en-US" altLang="ko-KR" b="1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recurrent (≥10%) </a:t>
            </a:r>
            <a:r>
              <a:rPr lang="en-US" altLang="ko-KR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s</a:t>
            </a:r>
            <a:r>
              <a:rPr lang="en-US" altLang="ko-KR" b="1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deletions.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8303318"/>
              </p:ext>
            </p:extLst>
          </p:nvPr>
        </p:nvGraphicFramePr>
        <p:xfrm>
          <a:off x="602266" y="1268760"/>
          <a:ext cx="8229600" cy="4384594"/>
        </p:xfrm>
        <a:graphic>
          <a:graphicData uri="http://schemas.openxmlformats.org/drawingml/2006/table">
            <a:tbl>
              <a:tblPr firstRow="1" firstCol="1" bandRow="1">
                <a:tableStyleId>{D27102A9-8310-4765-A935-A1911B00CA55}</a:tableStyleId>
              </a:tblPr>
              <a:tblGrid>
                <a:gridCol w="360040"/>
                <a:gridCol w="1008112"/>
                <a:gridCol w="116468"/>
                <a:gridCol w="819636"/>
                <a:gridCol w="179437"/>
                <a:gridCol w="684659"/>
                <a:gridCol w="199200"/>
                <a:gridCol w="885505"/>
                <a:gridCol w="787503"/>
                <a:gridCol w="3189040"/>
              </a:tblGrid>
              <a:tr h="317296">
                <a:tc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art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op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ze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toband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requency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Symbol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</a:tr>
              <a:tr h="193903">
                <a:tc gridSpan="10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744441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117250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000844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83594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13 - q24.2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1L6, TMEM65, TRMT12, RNF139, TATDN1, NDUFB9, MTSS1, LOC157381, ZNF572, SQLE, KIAA0196, NSMCE2, TRIB1, FAM84B, POU5F1P1, POU5F1B, LOC727677, MYC, PVT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</a:tr>
              <a:tr h="198309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818268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8992002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3734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2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%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YC, PVT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</a:tr>
              <a:tr h="1570387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547406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508281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35407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AC1, EIF2C2, PTK2, DENND3, SLC45A4, LOC731779, GPR20, PTP4A3, FLJ43860, NCRNA00051, TSNARE1, BAI1, ARC, JRK, PSCA, LY6K, C8orf55, SLURP1, LYPD2, LYNX1, LY6D, GML, CYP11B1, CYP11B2, LOC100133669, LY6E, C8orf31, LY6H, GPIHBP1, ZFP41, GLI4, ZNF696, TOP1MT, C8orf51, RHPN1, MAFA, ZC3H3, GSDMD, C8orf73, NAPRT1, EEF1D, TIGD5, PYCRL, TSTA3, ZNF623, ZNF707, BREA2, MAPK15, FAM83H, SCRIB, PUF60, NRBP2, EPPK1, PLEC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</a:tr>
              <a:tr h="30113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127912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320558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2646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q12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RBB2, C17orf37, GRB7, IKZF3, ZPBP2, GSDMB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</a:tr>
              <a:tr h="512667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266058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379118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113060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1.1 - q13.3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0, CDH22, SLC35C2, ELMO2, LOC100240726, ZNF334, C20orf123, SLC13A3, TP53RK, SLC2A10, EYA2, etc.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</a:tr>
              <a:tr h="193903">
                <a:tc gridSpan="10">
                  <a:txBody>
                    <a:bodyPr/>
                    <a:lstStyle/>
                    <a:p>
                      <a:pPr algn="l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17627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42634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481240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899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14.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%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HIT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</a:tr>
              <a:tr h="176276"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636302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2836985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68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q26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%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  <a:tc>
                  <a:txBody>
                    <a:bodyPr/>
                    <a:lstStyle/>
                    <a:p>
                      <a:pPr algn="ctr" latinLnBrk="0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K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/>
                </a:tc>
              </a:tr>
            </a:tbl>
          </a:graphicData>
        </a:graphic>
      </p:graphicFrame>
      <p:sp>
        <p:nvSpPr>
          <p:cNvPr id="4" name="직사각형 3"/>
          <p:cNvSpPr/>
          <p:nvPr/>
        </p:nvSpPr>
        <p:spPr>
          <a:xfrm>
            <a:off x="490115" y="5697628"/>
            <a:ext cx="8352928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800" b="1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i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mal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mon regions of recurrent (≥10%) amplifications or deletions in the 88 stomach cancers were analyzed. </a:t>
            </a:r>
            <a:endParaRPr lang="en-US" altLang="ko-KR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="1" baseline="30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identified when the normalized log2 ratio was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≥ 0.8 (copy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≥ 5).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milarly, deletions were identified when the normalized log2 ratio was 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≤ −0.8 (copy number = 0).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5032378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394467" y="116632"/>
            <a:ext cx="83529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G.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urrent amplification or deletion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. 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7446201"/>
              </p:ext>
            </p:extLst>
          </p:nvPr>
        </p:nvGraphicFramePr>
        <p:xfrm>
          <a:off x="395536" y="620688"/>
          <a:ext cx="8391562" cy="6079157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482582"/>
                <a:gridCol w="790898"/>
                <a:gridCol w="790898"/>
                <a:gridCol w="790898"/>
                <a:gridCol w="790898"/>
                <a:gridCol w="790898"/>
                <a:gridCol w="790898"/>
                <a:gridCol w="790898"/>
                <a:gridCol w="790898"/>
                <a:gridCol w="790898"/>
                <a:gridCol w="790898"/>
              </a:tblGrid>
              <a:tr h="288032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en-US" altLang="ko-KR" sz="12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.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ent </a:t>
                      </a:r>
                      <a:r>
                        <a:rPr lang="en-US" sz="12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</a:t>
                      </a:r>
                      <a:r>
                        <a:rPr lang="en-US" sz="1200" baseline="300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ukamoto et al. 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10]</a:t>
                      </a:r>
                      <a:r>
                        <a:rPr lang="en-US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n et al.[</a:t>
                      </a:r>
                      <a:r>
                        <a:rPr lang="it-IT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]</a:t>
                      </a:r>
                      <a:r>
                        <a:rPr lang="it-IT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ng et al. [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]</a:t>
                      </a:r>
                      <a:r>
                        <a:rPr lang="en-US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s et 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.[14]</a:t>
                      </a:r>
                      <a:r>
                        <a:rPr lang="en-US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16024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</a:tr>
              <a:tr h="46397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q21.2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q42.3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q42.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p36.22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q21.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q42.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p13.7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p36.1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q44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309317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q32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q37.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46397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14.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q27.1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14.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14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14.2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14.2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q27.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26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p14.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q26.3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309317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q22.1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q34.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413165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13.2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q11.2-q12.1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15.2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15.3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q12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p13.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q11.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q23.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46397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q26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p2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p12.2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p21.1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p25.3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p21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q1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q2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p25.3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q26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775018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p1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q21.2-q21.3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p21.1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p12.2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p12.1-p11.1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q11.21-q11.23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q21.12-q22.1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p11.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p22.3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q21.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q31.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q31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q36.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465701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0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p23.13-q24.21,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21,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p22-p23.1,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2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1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12-q24.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p11.21-q11.1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11.1-q24.3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p23.1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q24.21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p23.32,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46397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p21.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p2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p24.1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q34.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p13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p24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p21.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46397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q22.2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q26.13,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p15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q22.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q23.3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309317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q1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p12-p1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p13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q13.3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p15.4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q22.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309317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p12.1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q15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p13.3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6381789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539552" y="188640"/>
            <a:ext cx="83529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G.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urrent amplification or deletion </a:t>
            </a:r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ong </a:t>
            </a:r>
            <a:r>
              <a:rPr lang="en-US" altLang="ko-K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udies. 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8606945"/>
              </p:ext>
            </p:extLst>
          </p:nvPr>
        </p:nvGraphicFramePr>
        <p:xfrm>
          <a:off x="497083" y="620688"/>
          <a:ext cx="8251381" cy="5050818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474521"/>
                <a:gridCol w="777686"/>
                <a:gridCol w="777686"/>
                <a:gridCol w="777686"/>
                <a:gridCol w="777686"/>
                <a:gridCol w="777686"/>
                <a:gridCol w="777686"/>
                <a:gridCol w="777686"/>
                <a:gridCol w="777686"/>
                <a:gridCol w="777686"/>
                <a:gridCol w="777686"/>
              </a:tblGrid>
              <a:tr h="246758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en-US" altLang="ko-KR" sz="1200" dirty="0" smtClean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altLang="ko-KR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r.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ent </a:t>
                      </a:r>
                      <a:r>
                        <a:rPr lang="en-US" sz="12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</a:t>
                      </a:r>
                      <a:r>
                        <a:rPr lang="en-US" sz="1200" baseline="30000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sukamoto et al. 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10]</a:t>
                      </a:r>
                      <a:r>
                        <a:rPr lang="en-US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it-IT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n et al.[</a:t>
                      </a:r>
                      <a:r>
                        <a:rPr lang="it-IT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]</a:t>
                      </a:r>
                      <a:r>
                        <a:rPr lang="it-IT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ng et al. [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]</a:t>
                      </a:r>
                      <a:r>
                        <a:rPr lang="en-US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ss et </a:t>
                      </a:r>
                      <a:r>
                        <a:rPr lang="en-US" sz="12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l.[14]</a:t>
                      </a:r>
                      <a:r>
                        <a:rPr lang="en-US" sz="1200" baseline="30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</a:t>
                      </a:r>
                      <a:endParaRPr lang="ko-KR" sz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</a:tr>
              <a:tr h="257298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fica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letions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</a:tr>
              <a:tr h="171142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p12.1,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q15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p13.3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72287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q13.3,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q14.11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q12.3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q22.1,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q12.1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71142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q13.3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q32.3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1109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q26.1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q15.1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71142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q23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p13.3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q23.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72287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q1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q12-q2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q11.2-q12,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q21.1-q21.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q1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p1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q24.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257858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11.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2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12,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22,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2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22.1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11.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q21.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71142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q13.12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q11-q13.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q1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p13.3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q13.14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343429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1.1-q13.3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1.23, </a:t>
                      </a:r>
                      <a:endParaRPr lang="ko-KR" sz="10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3.1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2-20q13.3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p13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p12.1-p11.23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1.21-q13.2 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3.33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q13.2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p12.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71142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q21.1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q11.2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q22.1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1109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q13.31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256712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/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q27.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p21.1,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q22.2</a:t>
                      </a:r>
                      <a:endParaRPr lang="ko-KR" sz="10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q21.33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  <a:tr h="111096">
                <a:tc>
                  <a:txBody>
                    <a:bodyPr/>
                    <a:lstStyle/>
                    <a:p>
                      <a:pPr algn="ctr" latinLnBrk="1">
                        <a:spcAft>
                          <a:spcPts val="0"/>
                        </a:spcAft>
                      </a:pPr>
                      <a:r>
                        <a:rPr lang="en-US" sz="1000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 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l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l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l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l" latinLnBrk="1">
                        <a:spcAft>
                          <a:spcPts val="0"/>
                        </a:spcAft>
                      </a:pPr>
                      <a:r>
                        <a:rPr lang="ko-KR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 </a:t>
                      </a:r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endParaRPr lang="ko-KR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1020" marR="1020" marT="1020" marB="0"/>
                </a:tc>
                <a:tc>
                  <a:txBody>
                    <a:bodyPr/>
                    <a:lstStyle/>
                    <a:p>
                      <a:pPr algn="l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algn="l" latinLnBrk="1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ko-KR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</a:tr>
            </a:tbl>
          </a:graphicData>
        </a:graphic>
      </p:graphicFrame>
      <p:sp>
        <p:nvSpPr>
          <p:cNvPr id="6" name="직사각형 5"/>
          <p:cNvSpPr/>
          <p:nvPr/>
        </p:nvSpPr>
        <p:spPr>
          <a:xfrm>
            <a:off x="451416" y="5733256"/>
            <a:ext cx="624644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al common regions of recurrent (≥10%) amplifications or deletions in 88 stomach cancers. 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al common regions of recurrent (≥10%) amplifications or deletions in 30 stomach cancers. 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gions of recurrent (≥7%) amplifications or deletions in 72 stomach cancers. 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ko-KR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al common regions of recurrent (≥ 25%) copy number amplifications and deletions in 27 stomach cancers</a:t>
            </a:r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r>
              <a:rPr lang="en-US" altLang="ko-KR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 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mplifications or deletions in 295 primary gastric adenocarcinomas.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ko-KR" altLang="ko-K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3811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6518</TotalTime>
  <Words>1884</Words>
  <Application>Microsoft Office PowerPoint</Application>
  <PresentationFormat>화면 슬라이드 쇼(4:3)</PresentationFormat>
  <Paragraphs>1271</Paragraphs>
  <Slides>1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2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덕환</dc:creator>
  <cp:lastModifiedBy>김덕환</cp:lastModifiedBy>
  <cp:revision>84</cp:revision>
  <cp:lastPrinted>2015-06-01T05:23:00Z</cp:lastPrinted>
  <dcterms:created xsi:type="dcterms:W3CDTF">2014-07-20T06:20:40Z</dcterms:created>
  <dcterms:modified xsi:type="dcterms:W3CDTF">2015-03-01T07:42:57Z</dcterms:modified>
</cp:coreProperties>
</file>